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168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5%20&#23398;&#29983;&#27605;&#19994;&#35770;&#25991;&#25351;&#23548;\2021-2022\&#65281;&#29579;&#23011;&#23011;5604200233\20230403&#25968;&#25454;&#35760;&#24405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5%20&#23398;&#29983;&#27605;&#19994;&#35770;&#25991;&#25351;&#23548;\2021-2022\&#65281;&#29579;&#23011;&#23011;5604200233\20230403&#25968;&#25454;&#35760;&#24405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773840769903763"/>
          <c:y val="5.1400554097404488E-2"/>
          <c:w val="0.82781714785651794"/>
          <c:h val="0.77623833479148452"/>
        </c:manualLayout>
      </c:layout>
      <c:scatterChart>
        <c:scatterStyle val="lineMarker"/>
        <c:varyColors val="0"/>
        <c:ser>
          <c:idx val="0"/>
          <c:order val="0"/>
          <c:spPr>
            <a:ln>
              <a:noFill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3828471128608924"/>
                  <c:y val="1.0106080489938758E-2"/>
                </c:manualLayout>
              </c:layout>
              <c:numFmt formatCode="General" sourceLinked="0"/>
            </c:trendlineLbl>
          </c:trendline>
          <c:xVal>
            <c:numRef>
              <c:f>芝麻素和芝麻林素!$D$2:$D$5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20</c:v>
                </c:pt>
              </c:numCache>
            </c:numRef>
          </c:xVal>
          <c:yVal>
            <c:numRef>
              <c:f>芝麻素和芝麻林素!$E$2:$E$5</c:f>
              <c:numCache>
                <c:formatCode>General</c:formatCode>
                <c:ptCount val="4"/>
                <c:pt idx="0">
                  <c:v>8.35</c:v>
                </c:pt>
                <c:pt idx="1">
                  <c:v>11.93</c:v>
                </c:pt>
                <c:pt idx="2">
                  <c:v>24.62</c:v>
                </c:pt>
                <c:pt idx="3">
                  <c:v>121.4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167296"/>
        <c:axId val="176390144"/>
      </c:scatterChart>
      <c:valAx>
        <c:axId val="135167296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entration/(ug/m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43023709536307958"/>
              <c:y val="0.906866797900262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/>
            </a:pPr>
            <a:endParaRPr lang="zh-CN"/>
          </a:p>
        </c:txPr>
        <c:crossAx val="176390144"/>
        <c:crosses val="autoZero"/>
        <c:crossBetween val="midCat"/>
      </c:valAx>
      <c:valAx>
        <c:axId val="1763901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ak area/(mAU</a:t>
                </a:r>
                <a:r>
                  <a:rPr lang="en-US" altLang="zh-CN" sz="800" b="0" i="0" u="none" strike="noStrike" baseline="0">
                    <a:effectLst/>
                  </a:rPr>
                  <a:t>· </a:t>
                </a:r>
                <a:r>
                  <a:rPr lang="en-US"/>
                  <a:t>S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1.5220034995625544E-2"/>
              <c:y val="0.273674905220180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516729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84951881014874"/>
          <c:y val="5.1400554097404488E-2"/>
          <c:w val="0.84170603674540678"/>
          <c:h val="0.8040161125692622"/>
        </c:manualLayout>
      </c:layout>
      <c:scatterChart>
        <c:scatterStyle val="lineMarker"/>
        <c:varyColors val="0"/>
        <c:ser>
          <c:idx val="0"/>
          <c:order val="0"/>
          <c:spPr>
            <a:ln>
              <a:noFill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36618044619422574"/>
                  <c:y val="1.1428988043161271E-2"/>
                </c:manualLayout>
              </c:layout>
              <c:numFmt formatCode="General" sourceLinked="0"/>
            </c:trendlineLbl>
          </c:trendline>
          <c:xVal>
            <c:numRef>
              <c:f>芝麻素和芝麻林素!$Q$2:$Q$5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20</c:v>
                </c:pt>
              </c:numCache>
            </c:numRef>
          </c:xVal>
          <c:yVal>
            <c:numRef>
              <c:f>芝麻素和芝麻林素!$R$2:$R$5</c:f>
              <c:numCache>
                <c:formatCode>General</c:formatCode>
                <c:ptCount val="4"/>
                <c:pt idx="0">
                  <c:v>11.12</c:v>
                </c:pt>
                <c:pt idx="1">
                  <c:v>15.02</c:v>
                </c:pt>
                <c:pt idx="2">
                  <c:v>31.02</c:v>
                </c:pt>
                <c:pt idx="3">
                  <c:v>155.449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5959424"/>
        <c:axId val="175960000"/>
      </c:scatterChart>
      <c:valAx>
        <c:axId val="175959424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entration/(ug/mL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4330148731408574"/>
              <c:y val="0.9346445756780402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/>
            </a:pPr>
            <a:endParaRPr lang="zh-CN"/>
          </a:p>
        </c:txPr>
        <c:crossAx val="175960000"/>
        <c:crosses val="autoZero"/>
        <c:crossBetween val="midCat"/>
      </c:valAx>
      <c:valAx>
        <c:axId val="1759600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ak area/(mAU</a:t>
                </a:r>
                <a:r>
                  <a:rPr lang="en-US" altLang="zh-CN" sz="800" b="0" i="0" u="none" strike="noStrike" baseline="0">
                    <a:effectLst/>
                  </a:rPr>
                  <a:t>· </a:t>
                </a:r>
                <a:r>
                  <a:rPr lang="en-US"/>
                  <a:t>S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1.5220034995625544E-2"/>
              <c:y val="0.273674905220180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7595942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="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3/6/26/Mon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27784" y="4581128"/>
            <a:ext cx="4968552" cy="43204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Curve of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sesamin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standard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图表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9141877"/>
              </p:ext>
            </p:extLst>
          </p:nvPr>
        </p:nvGraphicFramePr>
        <p:xfrm>
          <a:off x="1475656" y="764704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6118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843808" y="4581128"/>
            <a:ext cx="4968552" cy="43204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Curve of </a:t>
            </a:r>
            <a:r>
              <a:rPr lang="en-US" altLang="zh-CN" sz="2000" dirty="0" err="1">
                <a:latin typeface="Times New Roman" pitchFamily="18" charset="0"/>
                <a:cs typeface="Times New Roman" pitchFamily="18" charset="0"/>
              </a:rPr>
              <a:t>sesamolin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 standard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图表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803506"/>
              </p:ext>
            </p:extLst>
          </p:nvPr>
        </p:nvGraphicFramePr>
        <p:xfrm>
          <a:off x="2123728" y="836712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25534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6</Words>
  <Application>Microsoft Office PowerPoint</Application>
  <PresentationFormat>全屏显示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</cp:lastModifiedBy>
  <cp:revision>10</cp:revision>
  <dcterms:created xsi:type="dcterms:W3CDTF">2022-04-15T23:11:46Z</dcterms:created>
  <dcterms:modified xsi:type="dcterms:W3CDTF">2023-06-26T08:40:27Z</dcterms:modified>
</cp:coreProperties>
</file>